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58" y="3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922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184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5774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990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800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6483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686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941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506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671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748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C0232-D629-4F58-A91D-B1380271E108}" type="datetimeFigureOut">
              <a:rPr kumimoji="1" lang="ja-JP" altLang="en-US" smtClean="0"/>
              <a:t>2022/10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4D8E2-7F0B-4F2F-8BAF-52BC325347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06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6C523CE-8BA3-4B4B-B116-7C855DE4BE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217" t="12303" r="29289" b="11607"/>
          <a:stretch/>
        </p:blipFill>
        <p:spPr>
          <a:xfrm>
            <a:off x="577969" y="1120728"/>
            <a:ext cx="4375030" cy="172932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D43ED8CD-2555-4836-9EBD-6CC08E7EFD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34" t="55993" r="36934" b="13580"/>
          <a:stretch/>
        </p:blipFill>
        <p:spPr>
          <a:xfrm>
            <a:off x="577970" y="2808349"/>
            <a:ext cx="4375029" cy="169545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B5ADFC2-68ED-4077-AD59-367AF9DD3CFE}"/>
              </a:ext>
            </a:extLst>
          </p:cNvPr>
          <p:cNvSpPr txBox="1"/>
          <p:nvPr/>
        </p:nvSpPr>
        <p:spPr>
          <a:xfrm>
            <a:off x="1204292" y="4487911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9454435-6B58-4711-8257-CAE9F95FCC88}"/>
              </a:ext>
            </a:extLst>
          </p:cNvPr>
          <p:cNvSpPr txBox="1"/>
          <p:nvPr/>
        </p:nvSpPr>
        <p:spPr>
          <a:xfrm>
            <a:off x="1962158" y="4487911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13DE9CC-9FE7-4302-A241-3D508F349D43}"/>
              </a:ext>
            </a:extLst>
          </p:cNvPr>
          <p:cNvSpPr txBox="1"/>
          <p:nvPr/>
        </p:nvSpPr>
        <p:spPr>
          <a:xfrm>
            <a:off x="2743207" y="4487911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E5A6200-8744-4C93-98ED-E1DC51BFD483}"/>
              </a:ext>
            </a:extLst>
          </p:cNvPr>
          <p:cNvSpPr txBox="1"/>
          <p:nvPr/>
        </p:nvSpPr>
        <p:spPr>
          <a:xfrm>
            <a:off x="3567116" y="4487911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3CAB0BA-8CFB-465E-AAFA-B9BB2FCC7A4D}"/>
              </a:ext>
            </a:extLst>
          </p:cNvPr>
          <p:cNvSpPr txBox="1"/>
          <p:nvPr/>
        </p:nvSpPr>
        <p:spPr>
          <a:xfrm>
            <a:off x="4333876" y="4487911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EB983C4C-F8B1-453D-A38F-606F0AF86F79}"/>
              </a:ext>
            </a:extLst>
          </p:cNvPr>
          <p:cNvCxnSpPr>
            <a:cxnSpLocks/>
          </p:cNvCxnSpPr>
          <p:nvPr/>
        </p:nvCxnSpPr>
        <p:spPr>
          <a:xfrm>
            <a:off x="904875" y="4799078"/>
            <a:ext cx="819150" cy="0"/>
          </a:xfrm>
          <a:prstGeom prst="line">
            <a:avLst/>
          </a:prstGeom>
          <a:ln w="762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5C60225-8C5D-469B-B1E3-D6DC2FF874B3}"/>
              </a:ext>
            </a:extLst>
          </p:cNvPr>
          <p:cNvCxnSpPr>
            <a:cxnSpLocks/>
          </p:cNvCxnSpPr>
          <p:nvPr/>
        </p:nvCxnSpPr>
        <p:spPr>
          <a:xfrm>
            <a:off x="2200274" y="4799078"/>
            <a:ext cx="280988" cy="0"/>
          </a:xfrm>
          <a:prstGeom prst="line">
            <a:avLst/>
          </a:prstGeom>
          <a:ln w="762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5D507A1-E829-4409-B816-BF99C99723B8}"/>
              </a:ext>
            </a:extLst>
          </p:cNvPr>
          <p:cNvSpPr txBox="1"/>
          <p:nvPr/>
        </p:nvSpPr>
        <p:spPr>
          <a:xfrm>
            <a:off x="904875" y="4832748"/>
            <a:ext cx="904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egment 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49F0EA-0B66-4FE7-8AD6-C9B27B439A12}"/>
              </a:ext>
            </a:extLst>
          </p:cNvPr>
          <p:cNvSpPr txBox="1"/>
          <p:nvPr/>
        </p:nvSpPr>
        <p:spPr>
          <a:xfrm>
            <a:off x="1947863" y="4832748"/>
            <a:ext cx="904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Segment 7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6386EDE-3310-457E-919B-B26DB4A8DDF1}"/>
              </a:ext>
            </a:extLst>
          </p:cNvPr>
          <p:cNvSpPr txBox="1"/>
          <p:nvPr/>
        </p:nvSpPr>
        <p:spPr>
          <a:xfrm>
            <a:off x="224287" y="3282711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6.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AB61662-9B28-4A40-9780-B47993974DA6}"/>
              </a:ext>
            </a:extLst>
          </p:cNvPr>
          <p:cNvSpPr txBox="1"/>
          <p:nvPr/>
        </p:nvSpPr>
        <p:spPr>
          <a:xfrm rot="16200000">
            <a:off x="-355951" y="1666861"/>
            <a:ext cx="1035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milarity (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31FBC2D-91C9-476D-A8B5-42E58C6F5B8C}"/>
              </a:ext>
            </a:extLst>
          </p:cNvPr>
          <p:cNvSpPr txBox="1"/>
          <p:nvPr/>
        </p:nvSpPr>
        <p:spPr>
          <a:xfrm rot="16200000">
            <a:off x="-557123" y="3524086"/>
            <a:ext cx="1438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ootstrap support (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4D939E5-B849-4F8B-A397-A0F986553129}"/>
              </a:ext>
            </a:extLst>
          </p:cNvPr>
          <p:cNvSpPr txBox="1"/>
          <p:nvPr/>
        </p:nvSpPr>
        <p:spPr>
          <a:xfrm>
            <a:off x="221414" y="3797419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3.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C5E6FD1-38F6-4C68-9EBB-8A6862D345DD}"/>
              </a:ext>
            </a:extLst>
          </p:cNvPr>
          <p:cNvSpPr txBox="1"/>
          <p:nvPr/>
        </p:nvSpPr>
        <p:spPr>
          <a:xfrm>
            <a:off x="221414" y="2796762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4ADF7E0-7DD3-4854-90B3-589A66D0476D}"/>
              </a:ext>
            </a:extLst>
          </p:cNvPr>
          <p:cNvSpPr txBox="1"/>
          <p:nvPr/>
        </p:nvSpPr>
        <p:spPr>
          <a:xfrm>
            <a:off x="368833" y="4364547"/>
            <a:ext cx="2910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8556FD0-7479-4514-BE8D-69C5CC34D02B}"/>
              </a:ext>
            </a:extLst>
          </p:cNvPr>
          <p:cNvSpPr txBox="1"/>
          <p:nvPr/>
        </p:nvSpPr>
        <p:spPr>
          <a:xfrm>
            <a:off x="294104" y="1025878"/>
            <a:ext cx="41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B027633-005F-425C-8C65-726EFA4680B4}"/>
              </a:ext>
            </a:extLst>
          </p:cNvPr>
          <p:cNvSpPr txBox="1"/>
          <p:nvPr/>
        </p:nvSpPr>
        <p:spPr>
          <a:xfrm>
            <a:off x="213811" y="1433044"/>
            <a:ext cx="465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A06589D-B9D6-4048-80B6-55658592F66D}"/>
              </a:ext>
            </a:extLst>
          </p:cNvPr>
          <p:cNvSpPr txBox="1"/>
          <p:nvPr/>
        </p:nvSpPr>
        <p:spPr>
          <a:xfrm>
            <a:off x="294104" y="1839840"/>
            <a:ext cx="41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4541288-30D1-48DD-85B5-42C5E0189B82}"/>
              </a:ext>
            </a:extLst>
          </p:cNvPr>
          <p:cNvSpPr txBox="1"/>
          <p:nvPr/>
        </p:nvSpPr>
        <p:spPr>
          <a:xfrm>
            <a:off x="213091" y="2259916"/>
            <a:ext cx="465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2B234EF-6543-4FAA-986E-FC0989D41017}"/>
              </a:ext>
            </a:extLst>
          </p:cNvPr>
          <p:cNvSpPr txBox="1"/>
          <p:nvPr/>
        </p:nvSpPr>
        <p:spPr>
          <a:xfrm>
            <a:off x="357194" y="2673651"/>
            <a:ext cx="302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1535430-7645-46BE-B975-F839B6F88716}"/>
              </a:ext>
            </a:extLst>
          </p:cNvPr>
          <p:cNvSpPr txBox="1"/>
          <p:nvPr/>
        </p:nvSpPr>
        <p:spPr>
          <a:xfrm>
            <a:off x="119071" y="381053"/>
            <a:ext cx="1685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 Hex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E43986E-5A1C-4195-8477-4DACB1448BD4}"/>
              </a:ext>
            </a:extLst>
          </p:cNvPr>
          <p:cNvSpPr txBox="1"/>
          <p:nvPr/>
        </p:nvSpPr>
        <p:spPr>
          <a:xfrm>
            <a:off x="5143510" y="381053"/>
            <a:ext cx="23010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 E3 612R-Fibe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ECAB47A-F523-4F78-97A5-B5084C126356}"/>
              </a:ext>
            </a:extLst>
          </p:cNvPr>
          <p:cNvSpPr txBox="1"/>
          <p:nvPr/>
        </p:nvSpPr>
        <p:spPr>
          <a:xfrm>
            <a:off x="5143963" y="3282704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6.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9F399CD-C816-40CC-9084-16F0B7B5866C}"/>
              </a:ext>
            </a:extLst>
          </p:cNvPr>
          <p:cNvSpPr txBox="1"/>
          <p:nvPr/>
        </p:nvSpPr>
        <p:spPr>
          <a:xfrm rot="16200000">
            <a:off x="4573251" y="1666854"/>
            <a:ext cx="10357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milarity (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13CBA29-B5CA-4439-918A-1088390533B5}"/>
              </a:ext>
            </a:extLst>
          </p:cNvPr>
          <p:cNvSpPr txBox="1"/>
          <p:nvPr/>
        </p:nvSpPr>
        <p:spPr>
          <a:xfrm rot="16200000">
            <a:off x="4372079" y="3524079"/>
            <a:ext cx="14380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ootstrap support (%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6D449B3-02BC-47FF-8D72-CC2E9487D91A}"/>
              </a:ext>
            </a:extLst>
          </p:cNvPr>
          <p:cNvSpPr txBox="1"/>
          <p:nvPr/>
        </p:nvSpPr>
        <p:spPr>
          <a:xfrm>
            <a:off x="5141090" y="3797412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3.3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6F3DD5D-C290-4168-86E4-F4C056F305CC}"/>
              </a:ext>
            </a:extLst>
          </p:cNvPr>
          <p:cNvSpPr txBox="1"/>
          <p:nvPr/>
        </p:nvSpPr>
        <p:spPr>
          <a:xfrm>
            <a:off x="5141090" y="2796755"/>
            <a:ext cx="514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A8876AA-4654-427A-977C-39EACD65C181}"/>
              </a:ext>
            </a:extLst>
          </p:cNvPr>
          <p:cNvSpPr txBox="1"/>
          <p:nvPr/>
        </p:nvSpPr>
        <p:spPr>
          <a:xfrm>
            <a:off x="5288509" y="4364540"/>
            <a:ext cx="2910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66215D92-8E4F-4A47-9A44-ACA14294C165}"/>
              </a:ext>
            </a:extLst>
          </p:cNvPr>
          <p:cNvSpPr txBox="1"/>
          <p:nvPr/>
        </p:nvSpPr>
        <p:spPr>
          <a:xfrm>
            <a:off x="5213780" y="1025871"/>
            <a:ext cx="41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0092A89-3DBB-4A9F-BFAA-681ED35A1693}"/>
              </a:ext>
            </a:extLst>
          </p:cNvPr>
          <p:cNvSpPr txBox="1"/>
          <p:nvPr/>
        </p:nvSpPr>
        <p:spPr>
          <a:xfrm>
            <a:off x="5133487" y="1433037"/>
            <a:ext cx="465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7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8AD1CAA-141C-48F5-A3D6-0528880B955F}"/>
              </a:ext>
            </a:extLst>
          </p:cNvPr>
          <p:cNvSpPr txBox="1"/>
          <p:nvPr/>
        </p:nvSpPr>
        <p:spPr>
          <a:xfrm>
            <a:off x="5213780" y="1839833"/>
            <a:ext cx="416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C73863E-8AC0-4DFF-B2FD-500261D5CFCF}"/>
              </a:ext>
            </a:extLst>
          </p:cNvPr>
          <p:cNvSpPr txBox="1"/>
          <p:nvPr/>
        </p:nvSpPr>
        <p:spPr>
          <a:xfrm>
            <a:off x="5132767" y="2259909"/>
            <a:ext cx="4652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25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0ECA826-24D6-4087-865B-44BE2274A329}"/>
              </a:ext>
            </a:extLst>
          </p:cNvPr>
          <p:cNvSpPr txBox="1"/>
          <p:nvPr/>
        </p:nvSpPr>
        <p:spPr>
          <a:xfrm>
            <a:off x="5276870" y="2673644"/>
            <a:ext cx="3026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A85BC2D-65D4-491F-9D8E-AE920479BD34}"/>
              </a:ext>
            </a:extLst>
          </p:cNvPr>
          <p:cNvSpPr txBox="1"/>
          <p:nvPr/>
        </p:nvSpPr>
        <p:spPr>
          <a:xfrm>
            <a:off x="3218791" y="2442433"/>
            <a:ext cx="18847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Windows: 200bp. Step: 20bp.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apStrip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: On. Kimura (2-parameter). T/t: 2.0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AAAE3B4-FD6C-4857-BDAA-2B1DA6CF18C0}"/>
              </a:ext>
            </a:extLst>
          </p:cNvPr>
          <p:cNvSpPr txBox="1"/>
          <p:nvPr/>
        </p:nvSpPr>
        <p:spPr>
          <a:xfrm>
            <a:off x="1314450" y="922471"/>
            <a:ext cx="29993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mPlot query: PAdV-5/wild boar/JPN/Ino5/2020</a:t>
            </a: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3D6A8AB9-98ED-4AD1-8AEA-A7DB9826E795}"/>
              </a:ext>
            </a:extLst>
          </p:cNvPr>
          <p:cNvGrpSpPr/>
          <p:nvPr/>
        </p:nvGrpSpPr>
        <p:grpSpPr>
          <a:xfrm>
            <a:off x="2477139" y="3816617"/>
            <a:ext cx="2320636" cy="374656"/>
            <a:chOff x="3667878" y="891499"/>
            <a:chExt cx="1359061" cy="374656"/>
          </a:xfrm>
        </p:grpSpPr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BFCB19CD-869D-4303-85C6-92F7BBD7CD7F}"/>
                </a:ext>
              </a:extLst>
            </p:cNvPr>
            <p:cNvSpPr txBox="1"/>
            <p:nvPr/>
          </p:nvSpPr>
          <p:spPr>
            <a:xfrm>
              <a:off x="3777928" y="990281"/>
              <a:ext cx="123469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NF-70 (AF289262)</a:t>
              </a:r>
              <a:r>
                <a:rPr kumimoji="1" lang="en-US" altLang="ja-JP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kumimoji="1" lang="en-US" altLang="ja-JP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Wild_boar/JPN/Ino5/2020 </a:t>
              </a:r>
              <a:endParaRPr kumimoji="1" lang="ja-JP" alt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20E6E308-4C14-4E16-9282-DADD594FDEEB}"/>
                </a:ext>
              </a:extLst>
            </p:cNvPr>
            <p:cNvGrpSpPr/>
            <p:nvPr/>
          </p:nvGrpSpPr>
          <p:grpSpPr>
            <a:xfrm>
              <a:off x="3667878" y="891499"/>
              <a:ext cx="1359061" cy="374656"/>
              <a:chOff x="3667878" y="891499"/>
              <a:chExt cx="1359061" cy="374656"/>
            </a:xfrm>
          </p:grpSpPr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1AD5A995-3AD3-4DFC-9CC7-6434C5ADA9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7878" y="1178972"/>
                <a:ext cx="123694" cy="0"/>
              </a:xfrm>
              <a:prstGeom prst="line">
                <a:avLst/>
              </a:prstGeom>
              <a:ln w="28575">
                <a:solidFill>
                  <a:srgbClr val="CC00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99EABFE5-81D7-441F-8DC7-0E042B97E3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7878" y="1077100"/>
                <a:ext cx="123694" cy="0"/>
              </a:xfrm>
              <a:prstGeom prst="line">
                <a:avLst/>
              </a:prstGeom>
              <a:ln w="28575">
                <a:solidFill>
                  <a:srgbClr val="0099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978E73FD-6DFE-4D6D-8780-692A7022DE4C}"/>
                  </a:ext>
                </a:extLst>
              </p:cNvPr>
              <p:cNvCxnSpPr>
                <a:cxnSpLocks/>
                <a:endCxn id="53" idx="1"/>
              </p:cNvCxnSpPr>
              <p:nvPr/>
            </p:nvCxnSpPr>
            <p:spPr>
              <a:xfrm>
                <a:off x="3667878" y="976099"/>
                <a:ext cx="110050" cy="39"/>
              </a:xfrm>
              <a:prstGeom prst="line">
                <a:avLst/>
              </a:prstGeom>
              <a:ln w="28575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6BF09CF0-4BED-48F4-8DAB-0B353FEFD139}"/>
                  </a:ext>
                </a:extLst>
              </p:cNvPr>
              <p:cNvSpPr txBox="1"/>
              <p:nvPr/>
            </p:nvSpPr>
            <p:spPr>
              <a:xfrm>
                <a:off x="3777928" y="891499"/>
                <a:ext cx="10797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5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NF-70 (AF289262)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vs </a:t>
                </a:r>
                <a:r>
                  <a:rPr kumimoji="1" lang="es-ES" altLang="ja-JP" sz="5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AdV 2 KY19-1 (LC621239)</a:t>
                </a:r>
                <a:endParaRPr kumimoji="1" lang="ja-JP" altLang="en-US" sz="50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C767CB8E-0C8B-429A-815E-B4F3081F576D}"/>
                  </a:ext>
                </a:extLst>
              </p:cNvPr>
              <p:cNvSpPr txBox="1"/>
              <p:nvPr/>
            </p:nvSpPr>
            <p:spPr>
              <a:xfrm>
                <a:off x="3777345" y="1096878"/>
                <a:ext cx="124959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s-ES" altLang="ja-JP" sz="5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AdV 2 KY19-1 (LC621239)</a:t>
                </a:r>
                <a:r>
                  <a:rPr kumimoji="1" lang="en-US" altLang="ja-JP" sz="5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vs </a:t>
                </a:r>
                <a:r>
                  <a:rPr kumimoji="1" lang="en-US" altLang="ja-JP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ild_boar/JPN/Ino5/2020</a:t>
                </a:r>
                <a:r>
                  <a:rPr kumimoji="1" lang="en-US" altLang="ja-JP" sz="5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umimoji="1" lang="ja-JP" alt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6501BB37-F672-4424-A085-A39E7E6696C0}"/>
              </a:ext>
            </a:extLst>
          </p:cNvPr>
          <p:cNvCxnSpPr/>
          <p:nvPr/>
        </p:nvCxnSpPr>
        <p:spPr>
          <a:xfrm>
            <a:off x="3218791" y="2086054"/>
            <a:ext cx="252000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5E03A88-0EF1-46E4-B0ED-D1BABADD1087}"/>
              </a:ext>
            </a:extLst>
          </p:cNvPr>
          <p:cNvSpPr txBox="1"/>
          <p:nvPr/>
        </p:nvSpPr>
        <p:spPr>
          <a:xfrm>
            <a:off x="3462405" y="1958184"/>
            <a:ext cx="146685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NF-70 (AF289262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025D33C0-BFE1-45D8-AD1A-BCCA25A32C89}"/>
              </a:ext>
            </a:extLst>
          </p:cNvPr>
          <p:cNvCxnSpPr/>
          <p:nvPr/>
        </p:nvCxnSpPr>
        <p:spPr>
          <a:xfrm>
            <a:off x="3218791" y="2244837"/>
            <a:ext cx="252000" cy="0"/>
          </a:xfrm>
          <a:prstGeom prst="line">
            <a:avLst/>
          </a:prstGeom>
          <a:ln w="1905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24724A2-0BCC-44D0-9FF3-F5484F49C882}"/>
              </a:ext>
            </a:extLst>
          </p:cNvPr>
          <p:cNvSpPr txBox="1"/>
          <p:nvPr/>
        </p:nvSpPr>
        <p:spPr>
          <a:xfrm>
            <a:off x="3462327" y="2138601"/>
            <a:ext cx="1466850" cy="3025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8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ovine adenovirus 2 KY19-1 (LC621239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図 58">
            <a:extLst>
              <a:ext uri="{FF2B5EF4-FFF2-40B4-BE49-F238E27FC236}">
                <a16:creationId xmlns:a16="http://schemas.microsoft.com/office/drawing/2014/main" id="{14E0E88B-D693-4E72-9705-4BFDC477DDE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222" t="12149" r="29636" b="11234"/>
          <a:stretch/>
        </p:blipFill>
        <p:spPr>
          <a:xfrm>
            <a:off x="5481637" y="1106572"/>
            <a:ext cx="4318869" cy="1750853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4A7B7275-37AE-4A70-A9C7-18192C75F99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26" t="55206" r="36951" b="13638"/>
          <a:stretch/>
        </p:blipFill>
        <p:spPr>
          <a:xfrm>
            <a:off x="5485974" y="2796755"/>
            <a:ext cx="4314534" cy="1702286"/>
          </a:xfrm>
          <a:prstGeom prst="rect">
            <a:avLst/>
          </a:prstGeom>
        </p:spPr>
      </p:pic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39B6FFFA-D148-497C-A940-E24EA96DF139}"/>
              </a:ext>
            </a:extLst>
          </p:cNvPr>
          <p:cNvGrpSpPr/>
          <p:nvPr/>
        </p:nvGrpSpPr>
        <p:grpSpPr>
          <a:xfrm>
            <a:off x="7847209" y="3647189"/>
            <a:ext cx="2088845" cy="374656"/>
            <a:chOff x="3667878" y="891499"/>
            <a:chExt cx="1189167" cy="374656"/>
          </a:xfrm>
        </p:grpSpPr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763F34F-3950-48C3-9769-EF5A8C15DAF0}"/>
                </a:ext>
              </a:extLst>
            </p:cNvPr>
            <p:cNvSpPr txBox="1"/>
            <p:nvPr/>
          </p:nvSpPr>
          <p:spPr>
            <a:xfrm>
              <a:off x="3777928" y="990281"/>
              <a:ext cx="9310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NF-70 (AF289262)</a:t>
              </a:r>
              <a:r>
                <a:rPr kumimoji="1" lang="en-US" altLang="ja-JP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kumimoji="1" lang="en-US" altLang="ja-JP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Wild_boar/JPN/Ino5/2020 </a:t>
              </a:r>
              <a:endParaRPr kumimoji="1" lang="ja-JP" alt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グループ化 62">
              <a:extLst>
                <a:ext uri="{FF2B5EF4-FFF2-40B4-BE49-F238E27FC236}">
                  <a16:creationId xmlns:a16="http://schemas.microsoft.com/office/drawing/2014/main" id="{61798B38-EA88-4FF7-A658-EB8E1AFC9F32}"/>
                </a:ext>
              </a:extLst>
            </p:cNvPr>
            <p:cNvGrpSpPr/>
            <p:nvPr/>
          </p:nvGrpSpPr>
          <p:grpSpPr>
            <a:xfrm>
              <a:off x="3667878" y="891499"/>
              <a:ext cx="1189167" cy="374656"/>
              <a:chOff x="3667878" y="891499"/>
              <a:chExt cx="1189167" cy="374656"/>
            </a:xfrm>
          </p:grpSpPr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id="{5054C408-DD10-4BFC-BAC0-29B3FE95A1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7878" y="1178972"/>
                <a:ext cx="123694" cy="0"/>
              </a:xfrm>
              <a:prstGeom prst="line">
                <a:avLst/>
              </a:prstGeom>
              <a:ln w="28575">
                <a:solidFill>
                  <a:srgbClr val="CC00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id="{23F9FF5E-383A-4CFE-8710-BD2F8C68B0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67878" y="1077100"/>
                <a:ext cx="123694" cy="0"/>
              </a:xfrm>
              <a:prstGeom prst="line">
                <a:avLst/>
              </a:prstGeom>
              <a:ln w="28575">
                <a:solidFill>
                  <a:srgbClr val="0099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id="{F98A54DE-BDE5-43A8-9F62-5610583742A4}"/>
                  </a:ext>
                </a:extLst>
              </p:cNvPr>
              <p:cNvCxnSpPr>
                <a:cxnSpLocks/>
                <a:endCxn id="67" idx="1"/>
              </p:cNvCxnSpPr>
              <p:nvPr/>
            </p:nvCxnSpPr>
            <p:spPr>
              <a:xfrm>
                <a:off x="3667878" y="976099"/>
                <a:ext cx="110050" cy="39"/>
              </a:xfrm>
              <a:prstGeom prst="line">
                <a:avLst/>
              </a:prstGeom>
              <a:ln w="28575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55FD73A7-D4A1-4241-AF8C-3DEA3BB5B833}"/>
                  </a:ext>
                </a:extLst>
              </p:cNvPr>
              <p:cNvSpPr txBox="1"/>
              <p:nvPr/>
            </p:nvSpPr>
            <p:spPr>
              <a:xfrm>
                <a:off x="3777928" y="891499"/>
                <a:ext cx="9658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5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NF-70 (AF289262)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vs </a:t>
                </a:r>
                <a:r>
                  <a:rPr kumimoji="1" lang="es-ES" altLang="ja-JP" sz="5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AdV 2 KY19-1 (LC621239)</a:t>
                </a:r>
                <a:endParaRPr kumimoji="1" lang="ja-JP" altLang="en-US" sz="50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809D73C4-CE46-4978-A8D1-AE273B21A716}"/>
                  </a:ext>
                </a:extLst>
              </p:cNvPr>
              <p:cNvSpPr txBox="1"/>
              <p:nvPr/>
            </p:nvSpPr>
            <p:spPr>
              <a:xfrm>
                <a:off x="3777345" y="1096878"/>
                <a:ext cx="10797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s-ES" altLang="ja-JP" sz="5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AdV 2 KY19-1 (LC621239)</a:t>
                </a:r>
                <a:r>
                  <a:rPr kumimoji="1" lang="en-US" altLang="ja-JP" sz="5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vs </a:t>
                </a:r>
                <a:r>
                  <a:rPr kumimoji="1" lang="en-US" altLang="ja-JP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ild_boar/JPN/Ino5/2020</a:t>
                </a:r>
                <a:r>
                  <a:rPr kumimoji="1" lang="en-US" altLang="ja-JP" sz="5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umimoji="1" lang="ja-JP" altLang="en-US" sz="5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ED3963F2-6ECD-47B6-B636-1D4C86258A4D}"/>
              </a:ext>
            </a:extLst>
          </p:cNvPr>
          <p:cNvCxnSpPr/>
          <p:nvPr/>
        </p:nvCxnSpPr>
        <p:spPr>
          <a:xfrm>
            <a:off x="8204956" y="1601452"/>
            <a:ext cx="252000" cy="0"/>
          </a:xfrm>
          <a:prstGeom prst="line">
            <a:avLst/>
          </a:prstGeom>
          <a:ln w="19050">
            <a:solidFill>
              <a:schemeClr val="accent6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A47FBC5-A429-4F08-A310-779BB6B59A90}"/>
              </a:ext>
            </a:extLst>
          </p:cNvPr>
          <p:cNvSpPr txBox="1"/>
          <p:nvPr/>
        </p:nvSpPr>
        <p:spPr>
          <a:xfrm>
            <a:off x="8448570" y="1473582"/>
            <a:ext cx="1466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NF-70 (AF289262)</a:t>
            </a:r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58DFA94E-2BEC-4922-A81C-2B231E694688}"/>
              </a:ext>
            </a:extLst>
          </p:cNvPr>
          <p:cNvCxnSpPr/>
          <p:nvPr/>
        </p:nvCxnSpPr>
        <p:spPr>
          <a:xfrm>
            <a:off x="8204956" y="1922166"/>
            <a:ext cx="252000" cy="0"/>
          </a:xfrm>
          <a:prstGeom prst="line">
            <a:avLst/>
          </a:prstGeom>
          <a:ln w="19050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1D57AD8-CD31-4E73-B157-3D3C4D45E31E}"/>
              </a:ext>
            </a:extLst>
          </p:cNvPr>
          <p:cNvSpPr txBox="1"/>
          <p:nvPr/>
        </p:nvSpPr>
        <p:spPr>
          <a:xfrm>
            <a:off x="8448492" y="1815930"/>
            <a:ext cx="1466850" cy="3025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8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ovine adenovirus 2 KY19-1 (LC621239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16DB5923-DBEF-4A85-8257-F50F7CBF12A2}"/>
              </a:ext>
            </a:extLst>
          </p:cNvPr>
          <p:cNvCxnSpPr/>
          <p:nvPr/>
        </p:nvCxnSpPr>
        <p:spPr>
          <a:xfrm>
            <a:off x="8209713" y="1753852"/>
            <a:ext cx="252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0D65FA5-356C-495C-AB13-5DF2A53F1BF5}"/>
              </a:ext>
            </a:extLst>
          </p:cNvPr>
          <p:cNvSpPr txBox="1"/>
          <p:nvPr/>
        </p:nvSpPr>
        <p:spPr>
          <a:xfrm>
            <a:off x="8453327" y="1625982"/>
            <a:ext cx="1413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NF-61 (AF186621)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D0D5BA4-9D41-44C6-9253-E831F3F082D9}"/>
              </a:ext>
            </a:extLst>
          </p:cNvPr>
          <p:cNvSpPr txBox="1"/>
          <p:nvPr/>
        </p:nvSpPr>
        <p:spPr>
          <a:xfrm>
            <a:off x="8136706" y="2028363"/>
            <a:ext cx="18847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Windows: 200bp. Step: 20bp. </a:t>
            </a:r>
            <a:r>
              <a:rPr kumimoji="1" lang="en-US" altLang="ja-JP" sz="700" dirty="0" err="1">
                <a:latin typeface="Arial" panose="020B0604020202020204" pitchFamily="34" charset="0"/>
                <a:cs typeface="Arial" panose="020B0604020202020204" pitchFamily="34" charset="0"/>
              </a:rPr>
              <a:t>GapStrip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: On. Kimura (2-parameter). T/t: 2.0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854CA92-7FBA-40BF-8123-2CB6DBCE52FE}"/>
              </a:ext>
            </a:extLst>
          </p:cNvPr>
          <p:cNvSpPr txBox="1"/>
          <p:nvPr/>
        </p:nvSpPr>
        <p:spPr>
          <a:xfrm>
            <a:off x="6190873" y="917803"/>
            <a:ext cx="29993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imPlot query: PAdV-5/wild boar/JPN/Ino5/2020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2EAC69E5-5358-4C99-819A-17A055F1B9EF}"/>
              </a:ext>
            </a:extLst>
          </p:cNvPr>
          <p:cNvSpPr txBox="1"/>
          <p:nvPr/>
        </p:nvSpPr>
        <p:spPr>
          <a:xfrm>
            <a:off x="5942991" y="4487905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A6439F88-E596-4523-9E39-3DDAFC0EDBD5}"/>
              </a:ext>
            </a:extLst>
          </p:cNvPr>
          <p:cNvSpPr txBox="1"/>
          <p:nvPr/>
        </p:nvSpPr>
        <p:spPr>
          <a:xfrm>
            <a:off x="6467478" y="4487905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0F260FE9-36FF-4C1A-A66D-C6938E5A342E}"/>
              </a:ext>
            </a:extLst>
          </p:cNvPr>
          <p:cNvSpPr txBox="1"/>
          <p:nvPr/>
        </p:nvSpPr>
        <p:spPr>
          <a:xfrm>
            <a:off x="7038972" y="4487905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F279A91-AE3B-4645-A8EC-C1B5B8AE6C3E}"/>
              </a:ext>
            </a:extLst>
          </p:cNvPr>
          <p:cNvSpPr txBox="1"/>
          <p:nvPr/>
        </p:nvSpPr>
        <p:spPr>
          <a:xfrm>
            <a:off x="7634282" y="4487905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6C1833AA-5A57-45E3-98A4-FE53E0EF27CD}"/>
              </a:ext>
            </a:extLst>
          </p:cNvPr>
          <p:cNvSpPr txBox="1"/>
          <p:nvPr/>
        </p:nvSpPr>
        <p:spPr>
          <a:xfrm>
            <a:off x="8201026" y="4487905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6C6BBDA1-9FB7-4D39-AE1A-C89FACF8FB2F}"/>
              </a:ext>
            </a:extLst>
          </p:cNvPr>
          <p:cNvSpPr txBox="1"/>
          <p:nvPr/>
        </p:nvSpPr>
        <p:spPr>
          <a:xfrm>
            <a:off x="9296421" y="4487899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99531BF9-11CD-4E2B-ACE3-5F067E8784F4}"/>
              </a:ext>
            </a:extLst>
          </p:cNvPr>
          <p:cNvSpPr txBox="1"/>
          <p:nvPr/>
        </p:nvSpPr>
        <p:spPr>
          <a:xfrm>
            <a:off x="8739182" y="4487897"/>
            <a:ext cx="63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E4D76388-BBF1-43E0-BE15-57A93C12282A}"/>
              </a:ext>
            </a:extLst>
          </p:cNvPr>
          <p:cNvCxnSpPr>
            <a:cxnSpLocks/>
          </p:cNvCxnSpPr>
          <p:nvPr/>
        </p:nvCxnSpPr>
        <p:spPr>
          <a:xfrm>
            <a:off x="5519741" y="4799078"/>
            <a:ext cx="2484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376371CC-A1F9-4503-AB1A-C0B08570A61A}"/>
              </a:ext>
            </a:extLst>
          </p:cNvPr>
          <p:cNvSpPr txBox="1"/>
          <p:nvPr/>
        </p:nvSpPr>
        <p:spPr>
          <a:xfrm>
            <a:off x="6385883" y="4828851"/>
            <a:ext cx="904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E3 612R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直線コネクタ 88">
            <a:extLst>
              <a:ext uri="{FF2B5EF4-FFF2-40B4-BE49-F238E27FC236}">
                <a16:creationId xmlns:a16="http://schemas.microsoft.com/office/drawing/2014/main" id="{88004B40-DCCC-4905-900C-D802B6DFE37C}"/>
              </a:ext>
            </a:extLst>
          </p:cNvPr>
          <p:cNvCxnSpPr>
            <a:cxnSpLocks/>
          </p:cNvCxnSpPr>
          <p:nvPr/>
        </p:nvCxnSpPr>
        <p:spPr>
          <a:xfrm>
            <a:off x="8087535" y="4804833"/>
            <a:ext cx="162000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C69471F-FA3C-4322-9D8B-DE71C8481D33}"/>
              </a:ext>
            </a:extLst>
          </p:cNvPr>
          <p:cNvSpPr txBox="1"/>
          <p:nvPr/>
        </p:nvSpPr>
        <p:spPr>
          <a:xfrm>
            <a:off x="8599990" y="4834606"/>
            <a:ext cx="904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iber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07CF31D-E56A-4138-AE37-A5876CB5D993}"/>
              </a:ext>
            </a:extLst>
          </p:cNvPr>
          <p:cNvSpPr txBox="1"/>
          <p:nvPr/>
        </p:nvSpPr>
        <p:spPr>
          <a:xfrm>
            <a:off x="3218791" y="5212683"/>
            <a:ext cx="3886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Figure S1. Oba et al.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EA101E72-6E59-4F52-9678-D8ACE8010691}"/>
              </a:ext>
            </a:extLst>
          </p:cNvPr>
          <p:cNvSpPr/>
          <p:nvPr/>
        </p:nvSpPr>
        <p:spPr>
          <a:xfrm>
            <a:off x="285030" y="5914856"/>
            <a:ext cx="953140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imilarity plot of the whole genome of PAdV-5 HNF-70 (green curve) and bovine adenovirus 2 KY-19-1 (orange curve), and PAdV-5 Ino5 as query sequence, with sliding window of 200 nt and a moving step size of 20 nt (A). Recombination analysis of PAdV-5 HNF-70 vs. bovine adenovirus 2 KY19-1 (yellow curve), PAdV-5 HNF-70 vs. PAdV-5 Ino5 (green curve), and bovine adenovirus 2 KY19-1 vs. PAdV-5 Ino5 (purple curve) (B)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0897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</TotalTime>
  <Words>315</Words>
  <Application>Microsoft Office PowerPoint</Application>
  <PresentationFormat>A4 Paper (210x297 mm)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等线</vt:lpstr>
      <vt:lpstr>Arial</vt:lpstr>
      <vt:lpstr>Calibri</vt:lpstr>
      <vt:lpstr>Calibri Light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井 誠</dc:creator>
  <cp:lastModifiedBy>MDPI</cp:lastModifiedBy>
  <cp:revision>12</cp:revision>
  <dcterms:created xsi:type="dcterms:W3CDTF">2022-09-24T07:29:43Z</dcterms:created>
  <dcterms:modified xsi:type="dcterms:W3CDTF">2022-10-29T11:00:32Z</dcterms:modified>
</cp:coreProperties>
</file>